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6" r:id="rId2"/>
    <p:sldId id="263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52770E9-B651-4ABD-B1CC-501BA29A6E94}" v="3" dt="2026-04-03T15:40:51.8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86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holas Wallace" userId="7a92b5d4-21f1-4929-81f4-746d288668f5" providerId="ADAL" clId="{A52770E9-B651-4ABD-B1CC-501BA29A6E94}"/>
    <pc:docChg chg="undo custSel addSld delSld modSld">
      <pc:chgData name="Nicholas Wallace" userId="7a92b5d4-21f1-4929-81f4-746d288668f5" providerId="ADAL" clId="{A52770E9-B651-4ABD-B1CC-501BA29A6E94}" dt="2026-04-03T15:41:31.163" v="21" actId="20577"/>
      <pc:docMkLst>
        <pc:docMk/>
      </pc:docMkLst>
      <pc:sldChg chg="modSp add mod">
        <pc:chgData name="Nicholas Wallace" userId="7a92b5d4-21f1-4929-81f4-746d288668f5" providerId="ADAL" clId="{A52770E9-B651-4ABD-B1CC-501BA29A6E94}" dt="2026-04-03T15:41:31.163" v="21" actId="20577"/>
        <pc:sldMkLst>
          <pc:docMk/>
          <pc:sldMk cId="1632795120" sldId="263"/>
        </pc:sldMkLst>
        <pc:spChg chg="mod">
          <ac:chgData name="Nicholas Wallace" userId="7a92b5d4-21f1-4929-81f4-746d288668f5" providerId="ADAL" clId="{A52770E9-B651-4ABD-B1CC-501BA29A6E94}" dt="2026-04-03T15:41:31.163" v="21" actId="20577"/>
          <ac:spMkLst>
            <pc:docMk/>
            <pc:sldMk cId="1632795120" sldId="263"/>
            <ac:spMk id="3" creationId="{445869B9-D278-6FEE-AF88-42F4C27CC553}"/>
          </ac:spMkLst>
        </pc:spChg>
      </pc:sldChg>
      <pc:sldChg chg="del">
        <pc:chgData name="Nicholas Wallace" userId="7a92b5d4-21f1-4929-81f4-746d288668f5" providerId="ADAL" clId="{A52770E9-B651-4ABD-B1CC-501BA29A6E94}" dt="2026-03-31T21:51:09.920" v="1" actId="47"/>
        <pc:sldMkLst>
          <pc:docMk/>
          <pc:sldMk cId="4078592960" sldId="271"/>
        </pc:sldMkLst>
      </pc:sldChg>
      <pc:sldChg chg="addSp delSp modSp add mod">
        <pc:chgData name="Nicholas Wallace" userId="7a92b5d4-21f1-4929-81f4-746d288668f5" providerId="ADAL" clId="{A52770E9-B651-4ABD-B1CC-501BA29A6E94}" dt="2026-04-03T15:40:40.074" v="13" actId="20577"/>
        <pc:sldMkLst>
          <pc:docMk/>
          <pc:sldMk cId="3017115828" sldId="276"/>
        </pc:sldMkLst>
        <pc:spChg chg="mod">
          <ac:chgData name="Nicholas Wallace" userId="7a92b5d4-21f1-4929-81f4-746d288668f5" providerId="ADAL" clId="{A52770E9-B651-4ABD-B1CC-501BA29A6E94}" dt="2026-04-03T15:40:40.074" v="13" actId="20577"/>
          <ac:spMkLst>
            <pc:docMk/>
            <pc:sldMk cId="3017115828" sldId="276"/>
            <ac:spMk id="2" creationId="{000ACD47-B211-4B7E-A80B-83101E975AAB}"/>
          </ac:spMkLst>
        </pc:spChg>
        <pc:spChg chg="add del">
          <ac:chgData name="Nicholas Wallace" userId="7a92b5d4-21f1-4929-81f4-746d288668f5" providerId="ADAL" clId="{A52770E9-B651-4ABD-B1CC-501BA29A6E94}" dt="2026-03-31T21:59:29.362" v="3" actId="22"/>
          <ac:spMkLst>
            <pc:docMk/>
            <pc:sldMk cId="3017115828" sldId="276"/>
            <ac:spMk id="7" creationId="{45F4C8A5-6FBD-B7B2-F209-C98FAD6514D5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10" creationId="{C1267837-DF7C-4D3C-A754-91C10064D2A8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15" creationId="{51C61AE8-CD94-4254-8DEE-F239C21EDDF1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28" creationId="{B25B9EFC-072D-5458-6F3C-F625A9BD55F4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30" creationId="{134D2DDB-9A9B-4FB4-AF77-60A834BC6AE3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31" creationId="{CDAC5262-29DB-4F73-BEF3-B501D45ACD7E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32" creationId="{A21D8974-3798-4CBD-8B6A-32532D0074FD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33" creationId="{C37242A3-B7A3-43F9-9006-379B5D0CD35C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34" creationId="{DC2894D7-F369-46E5-8385-9DBC2D08BFFF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35" creationId="{4EE10BB4-F806-4A9D-8983-E6A6039848A1}"/>
          </ac:spMkLst>
        </pc:spChg>
        <pc:spChg chg="mod">
          <ac:chgData name="Nicholas Wallace" userId="7a92b5d4-21f1-4929-81f4-746d288668f5" providerId="ADAL" clId="{A52770E9-B651-4ABD-B1CC-501BA29A6E94}" dt="2026-04-03T15:40:25.931" v="9" actId="20577"/>
          <ac:spMkLst>
            <pc:docMk/>
            <pc:sldMk cId="3017115828" sldId="276"/>
            <ac:spMk id="40" creationId="{47124528-C16A-456E-8A51-9A20915699A6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44" creationId="{8515B843-BCC6-E0BC-ECB4-40AE476A0532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46" creationId="{5B4235B9-C7DA-4A29-DF4D-D5E2FACBFC69}"/>
          </ac:spMkLst>
        </pc:spChg>
        <pc:spChg chg="mod">
          <ac:chgData name="Nicholas Wallace" userId="7a92b5d4-21f1-4929-81f4-746d288668f5" providerId="ADAL" clId="{A52770E9-B651-4ABD-B1CC-501BA29A6E94}" dt="2026-04-03T15:40:31.917" v="11" actId="20577"/>
          <ac:spMkLst>
            <pc:docMk/>
            <pc:sldMk cId="3017115828" sldId="276"/>
            <ac:spMk id="48" creationId="{9B4D893E-8AE3-4267-A234-99DC7A9547F7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51" creationId="{46990232-DD29-7A68-5EA0-520D21CEAE3D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53" creationId="{8641FD3D-925E-40DC-8604-7B31BCF416A4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54" creationId="{240C46E7-0B44-49FB-B21F-E9171DD6BE5D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55" creationId="{2F2B7A06-956C-489F-BE84-37C78AD22E82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56" creationId="{5801D0B1-AB41-46F4-8E25-CCEFAC23CE2A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57" creationId="{04F37255-75D9-4B06-B7DB-DD9E566CE96A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58" creationId="{4193C031-EC46-4AF2-937D-E47291AD3421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60" creationId="{82FECBEC-6962-BDD4-5052-057BDCA41143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61" creationId="{8CA2635A-6706-3C4A-314C-7E440291BDAD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62" creationId="{3A27E937-791D-B25D-EF85-283C5354F502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66" creationId="{3C6B8A01-36F1-EF9A-C96A-545098FB73CD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69" creationId="{D68DEE07-B707-22EC-83C2-B8BDE186684E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70" creationId="{06292447-04C9-7E93-C31C-9E84A517CBC0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71" creationId="{528F0524-EEDD-4AAB-5B17-D2E7D990ABC4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72" creationId="{3B74F578-B7DF-ADCA-312D-BBE304EBAE58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73" creationId="{93227392-18AC-292D-7166-B4EDA0A45B1F}"/>
          </ac:spMkLst>
        </pc:spChg>
        <pc:spChg chg="mod">
          <ac:chgData name="Nicholas Wallace" userId="7a92b5d4-21f1-4929-81f4-746d288668f5" providerId="ADAL" clId="{A52770E9-B651-4ABD-B1CC-501BA29A6E94}" dt="2026-04-03T15:40:15.058" v="7" actId="1076"/>
          <ac:spMkLst>
            <pc:docMk/>
            <pc:sldMk cId="3017115828" sldId="276"/>
            <ac:spMk id="77" creationId="{4A3AA47D-4494-2DA9-DDEF-F4423A2220A8}"/>
          </ac:spMkLst>
        </pc:spChg>
        <pc:graphicFrameChg chg="mod">
          <ac:chgData name="Nicholas Wallace" userId="7a92b5d4-21f1-4929-81f4-746d288668f5" providerId="ADAL" clId="{A52770E9-B651-4ABD-B1CC-501BA29A6E94}" dt="2026-04-03T15:40:15.058" v="7" actId="1076"/>
          <ac:graphicFrameMkLst>
            <pc:docMk/>
            <pc:sldMk cId="3017115828" sldId="276"/>
            <ac:graphicFrameMk id="45" creationId="{0335F81C-2C60-4B09-B36E-5A0A9953EF15}"/>
          </ac:graphicFrameMkLst>
        </pc:graphicFrameChg>
        <pc:picChg chg="mod">
          <ac:chgData name="Nicholas Wallace" userId="7a92b5d4-21f1-4929-81f4-746d288668f5" providerId="ADAL" clId="{A52770E9-B651-4ABD-B1CC-501BA29A6E94}" dt="2026-04-03T15:40:15.058" v="7" actId="1076"/>
          <ac:picMkLst>
            <pc:docMk/>
            <pc:sldMk cId="3017115828" sldId="276"/>
            <ac:picMk id="50" creationId="{B7125189-643C-4397-92A2-A77AD3F16848}"/>
          </ac:picMkLst>
        </pc:picChg>
        <pc:picChg chg="mod">
          <ac:chgData name="Nicholas Wallace" userId="7a92b5d4-21f1-4929-81f4-746d288668f5" providerId="ADAL" clId="{A52770E9-B651-4ABD-B1CC-501BA29A6E94}" dt="2026-04-03T15:40:15.058" v="7" actId="1076"/>
          <ac:picMkLst>
            <pc:docMk/>
            <pc:sldMk cId="3017115828" sldId="276"/>
            <ac:picMk id="52" creationId="{FCFF8E1B-E084-4B66-87EC-BC7ADC609AE1}"/>
          </ac:picMkLst>
        </pc:pic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4" creationId="{479E38BC-D9DF-426B-9BF0-32C300CD505E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6" creationId="{4CD3D9BD-C259-42FE-BF40-07690B79AE59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8" creationId="{6AE26A57-00F5-40F6-8116-40472AE5E117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13" creationId="{3E89F23F-0949-4C70-B225-866B0C3D4074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16" creationId="{9BA16492-A656-41FB-9D4A-A4B98D7B729B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17" creationId="{E9597FFE-D4F0-4781-01AD-815909BE9FB5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18" creationId="{F621928F-BD1F-46D6-A7C7-BDC97EC79EDF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19" creationId="{4582801F-0609-4E38-9EA0-DCDB02EFCB27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20" creationId="{53AA56F3-EC83-4BC3-BD15-AD399215966C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21" creationId="{A780598E-CCBA-467B-A3EC-61FF35B41E5B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22" creationId="{D0D6ECDA-3254-4C1E-9262-0E71C1DDE312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23" creationId="{AEC98701-DF23-4764-A78A-25C20CA01E9E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27" creationId="{AD1BBCF4-EAE9-4702-80D8-78304F8740EC}"/>
          </ac:cxnSpMkLst>
        </pc:cxnChg>
        <pc:cxnChg chg="mod">
          <ac:chgData name="Nicholas Wallace" userId="7a92b5d4-21f1-4929-81f4-746d288668f5" providerId="ADAL" clId="{A52770E9-B651-4ABD-B1CC-501BA29A6E94}" dt="2026-04-03T15:40:15.058" v="7" actId="1076"/>
          <ac:cxnSpMkLst>
            <pc:docMk/>
            <pc:sldMk cId="3017115828" sldId="276"/>
            <ac:cxnSpMk id="41" creationId="{D2932F39-4FCF-4DA0-8C93-3BD24691FD55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8E9699-3A4E-402F-B7EE-D46DA7B4DA7D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49543E-A5E2-4F4A-ACBD-15EE0CD5E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429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54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987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82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10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397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06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03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375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59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02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705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67359F-9A48-4A05-BE6A-A9FF163E3EA8}" type="datetimeFigureOut">
              <a:rPr lang="en-US" smtClean="0"/>
              <a:t>4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98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47124528-C16A-456E-8A51-9A20915699A6}"/>
              </a:ext>
            </a:extLst>
          </p:cNvPr>
          <p:cNvSpPr txBox="1"/>
          <p:nvPr/>
        </p:nvSpPr>
        <p:spPr>
          <a:xfrm>
            <a:off x="18679" y="626510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00ACD47-B211-4B7E-A80B-83101E975AAB}"/>
              </a:ext>
            </a:extLst>
          </p:cNvPr>
          <p:cNvSpPr txBox="1"/>
          <p:nvPr/>
        </p:nvSpPr>
        <p:spPr>
          <a:xfrm>
            <a:off x="63305" y="4159444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1C61AE8-CD94-4254-8DEE-F239C21EDDF1}"/>
              </a:ext>
            </a:extLst>
          </p:cNvPr>
          <p:cNvSpPr txBox="1"/>
          <p:nvPr/>
        </p:nvSpPr>
        <p:spPr>
          <a:xfrm>
            <a:off x="552355" y="3017780"/>
            <a:ext cx="957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Tumor Growth (Diameter &gt; 5mm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AE26A57-00F5-40F6-8116-40472AE5E117}"/>
              </a:ext>
            </a:extLst>
          </p:cNvPr>
          <p:cNvCxnSpPr>
            <a:cxnSpLocks/>
            <a:stCxn id="10" idx="0"/>
          </p:cNvCxnSpPr>
          <p:nvPr/>
        </p:nvCxnSpPr>
        <p:spPr>
          <a:xfrm flipV="1">
            <a:off x="609368" y="3475574"/>
            <a:ext cx="5736" cy="38305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C1267837-DF7C-4D3C-A754-91C10064D2A8}"/>
              </a:ext>
            </a:extLst>
          </p:cNvPr>
          <p:cNvSpPr txBox="1"/>
          <p:nvPr/>
        </p:nvSpPr>
        <p:spPr>
          <a:xfrm>
            <a:off x="249333" y="3858627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Xenograft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mplantati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34D2DDB-9A9B-4FB4-AF77-60A834BC6AE3}"/>
              </a:ext>
            </a:extLst>
          </p:cNvPr>
          <p:cNvSpPr txBox="1"/>
          <p:nvPr/>
        </p:nvSpPr>
        <p:spPr>
          <a:xfrm>
            <a:off x="1573368" y="3271206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eek 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DAC5262-29DB-4F73-BEF3-B501D45ACD7E}"/>
              </a:ext>
            </a:extLst>
          </p:cNvPr>
          <p:cNvSpPr txBox="1"/>
          <p:nvPr/>
        </p:nvSpPr>
        <p:spPr>
          <a:xfrm>
            <a:off x="2278197" y="3271206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eek 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21D8974-3798-4CBD-8B6A-32532D0074FD}"/>
              </a:ext>
            </a:extLst>
          </p:cNvPr>
          <p:cNvSpPr txBox="1"/>
          <p:nvPr/>
        </p:nvSpPr>
        <p:spPr>
          <a:xfrm>
            <a:off x="2935938" y="3271206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eek 3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37242A3-B7A3-43F9-9006-379B5D0CD35C}"/>
              </a:ext>
            </a:extLst>
          </p:cNvPr>
          <p:cNvSpPr txBox="1"/>
          <p:nvPr/>
        </p:nvSpPr>
        <p:spPr>
          <a:xfrm>
            <a:off x="3622761" y="3271206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eek 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C2894D7-F369-46E5-8385-9DBC2D08BFFF}"/>
              </a:ext>
            </a:extLst>
          </p:cNvPr>
          <p:cNvSpPr txBox="1"/>
          <p:nvPr/>
        </p:nvSpPr>
        <p:spPr>
          <a:xfrm>
            <a:off x="4279453" y="3271206"/>
            <a:ext cx="5768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eek 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EE10BB4-F806-4A9D-8983-E6A6039848A1}"/>
              </a:ext>
            </a:extLst>
          </p:cNvPr>
          <p:cNvSpPr txBox="1"/>
          <p:nvPr/>
        </p:nvSpPr>
        <p:spPr>
          <a:xfrm>
            <a:off x="4889453" y="3271206"/>
            <a:ext cx="5811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Week 6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479E38BC-D9DF-426B-9BF0-32C300CD505E}"/>
              </a:ext>
            </a:extLst>
          </p:cNvPr>
          <p:cNvCxnSpPr>
            <a:cxnSpLocks/>
          </p:cNvCxnSpPr>
          <p:nvPr/>
        </p:nvCxnSpPr>
        <p:spPr>
          <a:xfrm>
            <a:off x="621813" y="3446931"/>
            <a:ext cx="788880" cy="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E89F23F-0949-4C70-B225-866B0C3D4074}"/>
              </a:ext>
            </a:extLst>
          </p:cNvPr>
          <p:cNvCxnSpPr/>
          <p:nvPr/>
        </p:nvCxnSpPr>
        <p:spPr>
          <a:xfrm>
            <a:off x="1491427" y="3306319"/>
            <a:ext cx="613864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9BA16492-A656-41FB-9D4A-A4B98D7B729B}"/>
              </a:ext>
            </a:extLst>
          </p:cNvPr>
          <p:cNvCxnSpPr>
            <a:cxnSpLocks/>
          </p:cNvCxnSpPr>
          <p:nvPr/>
        </p:nvCxnSpPr>
        <p:spPr>
          <a:xfrm>
            <a:off x="1457945" y="2853043"/>
            <a:ext cx="0" cy="4181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F621928F-BD1F-46D6-A7C7-BDC97EC79EDF}"/>
              </a:ext>
            </a:extLst>
          </p:cNvPr>
          <p:cNvCxnSpPr>
            <a:cxnSpLocks/>
          </p:cNvCxnSpPr>
          <p:nvPr/>
        </p:nvCxnSpPr>
        <p:spPr>
          <a:xfrm>
            <a:off x="2136528" y="2853038"/>
            <a:ext cx="0" cy="4181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582801F-0609-4E38-9EA0-DCDB02EFCB27}"/>
              </a:ext>
            </a:extLst>
          </p:cNvPr>
          <p:cNvCxnSpPr>
            <a:cxnSpLocks/>
          </p:cNvCxnSpPr>
          <p:nvPr/>
        </p:nvCxnSpPr>
        <p:spPr>
          <a:xfrm>
            <a:off x="2819297" y="2853034"/>
            <a:ext cx="0" cy="4181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3AA56F3-EC83-4BC3-BD15-AD399215966C}"/>
              </a:ext>
            </a:extLst>
          </p:cNvPr>
          <p:cNvCxnSpPr>
            <a:cxnSpLocks/>
          </p:cNvCxnSpPr>
          <p:nvPr/>
        </p:nvCxnSpPr>
        <p:spPr>
          <a:xfrm>
            <a:off x="3502668" y="2872282"/>
            <a:ext cx="0" cy="4181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780598E-CCBA-467B-A3EC-61FF35B41E5B}"/>
              </a:ext>
            </a:extLst>
          </p:cNvPr>
          <p:cNvCxnSpPr>
            <a:cxnSpLocks/>
          </p:cNvCxnSpPr>
          <p:nvPr/>
        </p:nvCxnSpPr>
        <p:spPr>
          <a:xfrm>
            <a:off x="4185436" y="2872277"/>
            <a:ext cx="0" cy="4181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D0D6ECDA-3254-4C1E-9262-0E71C1DDE312}"/>
              </a:ext>
            </a:extLst>
          </p:cNvPr>
          <p:cNvCxnSpPr>
            <a:cxnSpLocks/>
          </p:cNvCxnSpPr>
          <p:nvPr/>
        </p:nvCxnSpPr>
        <p:spPr>
          <a:xfrm>
            <a:off x="4862625" y="2853953"/>
            <a:ext cx="0" cy="41811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EC98701-DF23-4764-A78A-25C20CA01E9E}"/>
              </a:ext>
            </a:extLst>
          </p:cNvPr>
          <p:cNvCxnSpPr>
            <a:cxnSpLocks/>
          </p:cNvCxnSpPr>
          <p:nvPr/>
        </p:nvCxnSpPr>
        <p:spPr>
          <a:xfrm>
            <a:off x="1463418" y="3306314"/>
            <a:ext cx="3928669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AD1BBCF4-EAE9-4702-80D8-78304F8740EC}"/>
              </a:ext>
            </a:extLst>
          </p:cNvPr>
          <p:cNvCxnSpPr>
            <a:cxnSpLocks/>
          </p:cNvCxnSpPr>
          <p:nvPr/>
        </p:nvCxnSpPr>
        <p:spPr>
          <a:xfrm>
            <a:off x="4892716" y="3306314"/>
            <a:ext cx="501238" cy="0"/>
          </a:xfrm>
          <a:prstGeom prst="line">
            <a:avLst/>
          </a:prstGeom>
          <a:ln w="381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D2932F39-4FCF-4DA0-8C93-3BD24691FD55}"/>
              </a:ext>
            </a:extLst>
          </p:cNvPr>
          <p:cNvCxnSpPr>
            <a:cxnSpLocks/>
          </p:cNvCxnSpPr>
          <p:nvPr/>
        </p:nvCxnSpPr>
        <p:spPr>
          <a:xfrm>
            <a:off x="5392087" y="2907447"/>
            <a:ext cx="0" cy="356688"/>
          </a:xfrm>
          <a:prstGeom prst="straightConnector1">
            <a:avLst/>
          </a:prstGeom>
          <a:ln w="38100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5" name="Table 44">
            <a:extLst>
              <a:ext uri="{FF2B5EF4-FFF2-40B4-BE49-F238E27FC236}">
                <a16:creationId xmlns:a16="http://schemas.microsoft.com/office/drawing/2014/main" id="{0335F81C-2C60-4B09-B36E-5A0A9953EF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8186175"/>
              </p:ext>
            </p:extLst>
          </p:nvPr>
        </p:nvGraphicFramePr>
        <p:xfrm>
          <a:off x="291132" y="630195"/>
          <a:ext cx="5451696" cy="14848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01222">
                  <a:extLst>
                    <a:ext uri="{9D8B030D-6E8A-4147-A177-3AD203B41FA5}">
                      <a16:colId xmlns:a16="http://schemas.microsoft.com/office/drawing/2014/main" val="1299880023"/>
                    </a:ext>
                  </a:extLst>
                </a:gridCol>
                <a:gridCol w="905608">
                  <a:extLst>
                    <a:ext uri="{9D8B030D-6E8A-4147-A177-3AD203B41FA5}">
                      <a16:colId xmlns:a16="http://schemas.microsoft.com/office/drawing/2014/main" val="1250715025"/>
                    </a:ext>
                  </a:extLst>
                </a:gridCol>
                <a:gridCol w="905608">
                  <a:extLst>
                    <a:ext uri="{9D8B030D-6E8A-4147-A177-3AD203B41FA5}">
                      <a16:colId xmlns:a16="http://schemas.microsoft.com/office/drawing/2014/main" val="2345636752"/>
                    </a:ext>
                  </a:extLst>
                </a:gridCol>
                <a:gridCol w="1152580">
                  <a:extLst>
                    <a:ext uri="{9D8B030D-6E8A-4147-A177-3AD203B41FA5}">
                      <a16:colId xmlns:a16="http://schemas.microsoft.com/office/drawing/2014/main" val="3169893955"/>
                    </a:ext>
                  </a:extLst>
                </a:gridCol>
                <a:gridCol w="986678">
                  <a:extLst>
                    <a:ext uri="{9D8B030D-6E8A-4147-A177-3AD203B41FA5}">
                      <a16:colId xmlns:a16="http://schemas.microsoft.com/office/drawing/2014/main" val="3413829941"/>
                    </a:ext>
                  </a:extLst>
                </a:gridCol>
              </a:tblGrid>
              <a:tr h="169685">
                <a:tc>
                  <a:txBody>
                    <a:bodyPr/>
                    <a:lstStyle/>
                    <a:p>
                      <a:pPr marL="0" indent="0" algn="ctr" fontAlgn="b">
                        <a:buNone/>
                      </a:pPr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I. Monotherap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+mn-lt"/>
                        </a:rPr>
                        <a:t>Mock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8 mg/kg Cispla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100 mg/kg AOH1996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2779932897"/>
                  </a:ext>
                </a:extLst>
              </a:tr>
              <a:tr h="93558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4583318"/>
                  </a:ext>
                </a:extLst>
              </a:tr>
              <a:tr h="169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II. AOH1996 Dose Serie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+mn-lt"/>
                        </a:rPr>
                        <a:t>Mock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25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50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100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691499046"/>
                  </a:ext>
                </a:extLst>
              </a:tr>
              <a:tr h="93558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9374069"/>
                  </a:ext>
                </a:extLst>
              </a:tr>
              <a:tr h="169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III. Cisplatin Dose Serie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ock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4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8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1716940337"/>
                  </a:ext>
                </a:extLst>
              </a:tr>
              <a:tr h="93558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4006873"/>
                  </a:ext>
                </a:extLst>
              </a:tr>
              <a:tr h="169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IV. HeL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ock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4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8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4mg/kg + 25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1595518360"/>
                  </a:ext>
                </a:extLst>
              </a:tr>
              <a:tr h="93558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9</a:t>
                      </a: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0278628"/>
                  </a:ext>
                </a:extLst>
              </a:tr>
              <a:tr h="169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V. </a:t>
                      </a:r>
                      <a:r>
                        <a:rPr lang="en-US" sz="800" b="1" u="none" strike="noStrike" dirty="0" err="1">
                          <a:effectLst/>
                          <a:latin typeface="+mn-lt"/>
                        </a:rPr>
                        <a:t>CaSk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Mock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4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8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n-lt"/>
                        </a:rPr>
                        <a:t>4mg/kg + 25 mg/k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/>
                </a:tc>
                <a:extLst>
                  <a:ext uri="{0D108BD9-81ED-4DB2-BD59-A6C34878D82A}">
                    <a16:rowId xmlns:a16="http://schemas.microsoft.com/office/drawing/2014/main" val="2973437604"/>
                  </a:ext>
                </a:extLst>
              </a:tr>
              <a:tr h="93558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6</a:t>
                      </a: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6</a:t>
                      </a: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6</a:t>
                      </a: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=</a:t>
                      </a:r>
                      <a:r>
                        <a:rPr lang="en-US" sz="800" u="none" strike="noStrike" dirty="0">
                          <a:effectLst/>
                          <a:latin typeface="+mn-lt"/>
                        </a:rPr>
                        <a:t>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358" marR="5358" marT="5358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5928103"/>
                  </a:ext>
                </a:extLst>
              </a:tr>
            </a:tbl>
          </a:graphicData>
        </a:graphic>
      </p:graphicFrame>
      <p:sp>
        <p:nvSpPr>
          <p:cNvPr id="48" name="TextBox 47">
            <a:extLst>
              <a:ext uri="{FF2B5EF4-FFF2-40B4-BE49-F238E27FC236}">
                <a16:creationId xmlns:a16="http://schemas.microsoft.com/office/drawing/2014/main" id="{9B4D893E-8AE3-4267-A234-99DC7A9547F7}"/>
              </a:ext>
            </a:extLst>
          </p:cNvPr>
          <p:cNvSpPr txBox="1"/>
          <p:nvPr/>
        </p:nvSpPr>
        <p:spPr>
          <a:xfrm>
            <a:off x="-3424" y="256226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B7125189-643C-4397-92A2-A77AD3F168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22" t="14374" r="24402" b="13647"/>
          <a:stretch/>
        </p:blipFill>
        <p:spPr>
          <a:xfrm>
            <a:off x="4672969" y="4375271"/>
            <a:ext cx="2185031" cy="2033386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FCFF8E1B-E084-4B66-87EC-BC7ADC609A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4" t="16899" r="3009" b="11180"/>
          <a:stretch/>
        </p:blipFill>
        <p:spPr>
          <a:xfrm>
            <a:off x="1118605" y="4383144"/>
            <a:ext cx="3512610" cy="2033386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8641FD3D-925E-40DC-8604-7B31BCF416A4}"/>
              </a:ext>
            </a:extLst>
          </p:cNvPr>
          <p:cNvSpPr txBox="1"/>
          <p:nvPr/>
        </p:nvSpPr>
        <p:spPr>
          <a:xfrm>
            <a:off x="2256689" y="4188435"/>
            <a:ext cx="10518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HeLa Xenograft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40C46E7-0B44-49FB-B21F-E9171DD6BE5D}"/>
              </a:ext>
            </a:extLst>
          </p:cNvPr>
          <p:cNvSpPr txBox="1"/>
          <p:nvPr/>
        </p:nvSpPr>
        <p:spPr>
          <a:xfrm>
            <a:off x="5150739" y="4188435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CaSki Xenograft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F2B7A06-956C-489F-BE84-37C78AD22E82}"/>
              </a:ext>
            </a:extLst>
          </p:cNvPr>
          <p:cNvSpPr txBox="1"/>
          <p:nvPr/>
        </p:nvSpPr>
        <p:spPr>
          <a:xfrm>
            <a:off x="627202" y="4495535"/>
            <a:ext cx="4796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801D0B1-AB41-46F4-8E25-CCEFAC23CE2A}"/>
              </a:ext>
            </a:extLst>
          </p:cNvPr>
          <p:cNvSpPr txBox="1"/>
          <p:nvPr/>
        </p:nvSpPr>
        <p:spPr>
          <a:xfrm>
            <a:off x="541669" y="5636580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8 mg/kg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4F37255-75D9-4B06-B7DB-DD9E566CE96A}"/>
              </a:ext>
            </a:extLst>
          </p:cNvPr>
          <p:cNvSpPr txBox="1"/>
          <p:nvPr/>
        </p:nvSpPr>
        <p:spPr>
          <a:xfrm>
            <a:off x="550647" y="5075457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cs typeface="Arial" panose="020B0604020202020204" pitchFamily="34" charset="0"/>
              </a:rPr>
              <a:t>4 mg/kg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193C031-EC46-4AF2-937D-E47291AD3421}"/>
              </a:ext>
            </a:extLst>
          </p:cNvPr>
          <p:cNvSpPr txBox="1"/>
          <p:nvPr/>
        </p:nvSpPr>
        <p:spPr>
          <a:xfrm>
            <a:off x="-22470" y="6089727"/>
            <a:ext cx="12218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cs typeface="Arial" panose="020B0604020202020204" pitchFamily="34" charset="0"/>
              </a:rPr>
              <a:t>4 mg/kg cisplatin +</a:t>
            </a:r>
          </a:p>
          <a:p>
            <a:pPr algn="ctr"/>
            <a:r>
              <a:rPr lang="en-US" sz="1000" b="1" dirty="0">
                <a:cs typeface="Arial" panose="020B0604020202020204" pitchFamily="34" charset="0"/>
              </a:rPr>
              <a:t>25 mg/kg AOH1996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CD3D9BD-C259-42FE-BF40-07690B79AE59}"/>
              </a:ext>
            </a:extLst>
          </p:cNvPr>
          <p:cNvCxnSpPr>
            <a:cxnSpLocks/>
          </p:cNvCxnSpPr>
          <p:nvPr/>
        </p:nvCxnSpPr>
        <p:spPr>
          <a:xfrm>
            <a:off x="1463418" y="3446931"/>
            <a:ext cx="4089434" cy="0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E9597FFE-D4F0-4781-01AD-815909BE9FB5}"/>
              </a:ext>
            </a:extLst>
          </p:cNvPr>
          <p:cNvCxnSpPr>
            <a:cxnSpLocks/>
            <a:stCxn id="28" idx="0"/>
          </p:cNvCxnSpPr>
          <p:nvPr/>
        </p:nvCxnSpPr>
        <p:spPr>
          <a:xfrm flipV="1">
            <a:off x="1454441" y="3478849"/>
            <a:ext cx="5735" cy="38305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B25B9EFC-072D-5458-6F3C-F625A9BD55F4}"/>
              </a:ext>
            </a:extLst>
          </p:cNvPr>
          <p:cNvSpPr txBox="1"/>
          <p:nvPr/>
        </p:nvSpPr>
        <p:spPr>
          <a:xfrm>
            <a:off x="1132077" y="3861902"/>
            <a:ext cx="644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Treatment </a:t>
            </a:r>
          </a:p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Initiate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515B843-BCC6-E0BC-ECB4-40AE476A0532}"/>
              </a:ext>
            </a:extLst>
          </p:cNvPr>
          <p:cNvSpPr txBox="1"/>
          <p:nvPr/>
        </p:nvSpPr>
        <p:spPr>
          <a:xfrm>
            <a:off x="1144098" y="2721353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B4235B9-C7DA-4A29-DF4D-D5E2FACBFC69}"/>
              </a:ext>
            </a:extLst>
          </p:cNvPr>
          <p:cNvSpPr txBox="1"/>
          <p:nvPr/>
        </p:nvSpPr>
        <p:spPr>
          <a:xfrm>
            <a:off x="1829349" y="2721353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6990232-DD29-7A68-5EA0-520D21CEAE3D}"/>
              </a:ext>
            </a:extLst>
          </p:cNvPr>
          <p:cNvSpPr txBox="1"/>
          <p:nvPr/>
        </p:nvSpPr>
        <p:spPr>
          <a:xfrm>
            <a:off x="2514600" y="2721353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2FECBEC-6962-BDD4-5052-057BDCA41143}"/>
              </a:ext>
            </a:extLst>
          </p:cNvPr>
          <p:cNvSpPr txBox="1"/>
          <p:nvPr/>
        </p:nvSpPr>
        <p:spPr>
          <a:xfrm>
            <a:off x="3199851" y="2721353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CA2635A-6706-3C4A-314C-7E440291BDAD}"/>
              </a:ext>
            </a:extLst>
          </p:cNvPr>
          <p:cNvSpPr txBox="1"/>
          <p:nvPr/>
        </p:nvSpPr>
        <p:spPr>
          <a:xfrm>
            <a:off x="3885102" y="2721353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A27E937-791D-B25D-EF85-283C5354F502}"/>
              </a:ext>
            </a:extLst>
          </p:cNvPr>
          <p:cNvSpPr txBox="1"/>
          <p:nvPr/>
        </p:nvSpPr>
        <p:spPr>
          <a:xfrm>
            <a:off x="4570352" y="2721353"/>
            <a:ext cx="6447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C6B8A01-36F1-EF9A-C96A-545098FB73CD}"/>
              </a:ext>
            </a:extLst>
          </p:cNvPr>
          <p:cNvSpPr txBox="1"/>
          <p:nvPr/>
        </p:nvSpPr>
        <p:spPr>
          <a:xfrm>
            <a:off x="1490836" y="2996179"/>
            <a:ext cx="64472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H1996 BID</a:t>
            </a:r>
            <a:endParaRPr lang="en-US" dirty="0">
              <a:solidFill>
                <a:srgbClr val="0000FF"/>
              </a:solidFill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68DEE07-B707-22EC-83C2-B8BDE186684E}"/>
              </a:ext>
            </a:extLst>
          </p:cNvPr>
          <p:cNvSpPr txBox="1"/>
          <p:nvPr/>
        </p:nvSpPr>
        <p:spPr>
          <a:xfrm>
            <a:off x="2192184" y="3004037"/>
            <a:ext cx="64472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H1996 BID</a:t>
            </a:r>
            <a:endParaRPr lang="en-US" dirty="0">
              <a:solidFill>
                <a:srgbClr val="0000FF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6292447-04C9-7E93-C31C-9E84A517CBC0}"/>
              </a:ext>
            </a:extLst>
          </p:cNvPr>
          <p:cNvSpPr txBox="1"/>
          <p:nvPr/>
        </p:nvSpPr>
        <p:spPr>
          <a:xfrm>
            <a:off x="2849925" y="3005731"/>
            <a:ext cx="64472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H1996 BID</a:t>
            </a:r>
            <a:endParaRPr lang="en-US" dirty="0">
              <a:solidFill>
                <a:srgbClr val="0000FF"/>
              </a:solidFill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28F0524-EEDD-4AAB-5B17-D2E7D990ABC4}"/>
              </a:ext>
            </a:extLst>
          </p:cNvPr>
          <p:cNvSpPr txBox="1"/>
          <p:nvPr/>
        </p:nvSpPr>
        <p:spPr>
          <a:xfrm>
            <a:off x="3538148" y="3002391"/>
            <a:ext cx="64472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H1996 BID</a:t>
            </a:r>
            <a:endParaRPr lang="en-US" dirty="0">
              <a:solidFill>
                <a:srgbClr val="0000FF"/>
              </a:solidFill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B74F578-B7DF-ADCA-312D-BBE304EBAE58}"/>
              </a:ext>
            </a:extLst>
          </p:cNvPr>
          <p:cNvSpPr txBox="1"/>
          <p:nvPr/>
        </p:nvSpPr>
        <p:spPr>
          <a:xfrm>
            <a:off x="4169404" y="3004037"/>
            <a:ext cx="64472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H1996 BID</a:t>
            </a:r>
            <a:endParaRPr lang="en-US" dirty="0">
              <a:solidFill>
                <a:srgbClr val="0000FF"/>
              </a:solidFill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3227392-18AC-292D-7166-B4EDA0A45B1F}"/>
              </a:ext>
            </a:extLst>
          </p:cNvPr>
          <p:cNvSpPr txBox="1"/>
          <p:nvPr/>
        </p:nvSpPr>
        <p:spPr>
          <a:xfrm>
            <a:off x="4798099" y="2999578"/>
            <a:ext cx="64472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OH1996 BID</a:t>
            </a:r>
            <a:endParaRPr lang="en-US" dirty="0">
              <a:solidFill>
                <a:srgbClr val="0000FF"/>
              </a:solidFill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A3AA47D-4494-2DA9-DDEF-F4423A2220A8}"/>
              </a:ext>
            </a:extLst>
          </p:cNvPr>
          <p:cNvSpPr txBox="1"/>
          <p:nvPr/>
        </p:nvSpPr>
        <p:spPr>
          <a:xfrm>
            <a:off x="5049529" y="2644759"/>
            <a:ext cx="6447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Urine Collection</a:t>
            </a: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566C2125-9716-2FAA-DB89-C9E819A17C6D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6858000" cy="74562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l Figure 5:</a:t>
            </a:r>
          </a:p>
        </p:txBody>
      </p:sp>
    </p:spTree>
    <p:extLst>
      <p:ext uri="{BB962C8B-B14F-4D97-AF65-F5344CB8AC3E}">
        <p14:creationId xmlns:p14="http://schemas.microsoft.com/office/powerpoint/2010/main" val="3017115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6637B4-2A10-C83C-2390-C63C847BB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ge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5869B9-D278-6FEE-AF88-42F4C27CC5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algn="just">
              <a:spcAft>
                <a:spcPts val="1000"/>
              </a:spcAft>
            </a:pPr>
            <a:r>
              <a:rPr lang="en-US" sz="1800" b="1" i="1" u="sng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lang="en-US" sz="1800" b="1" i="1" u="sng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5: Xenograft Sizes, Study Arms and Treatment Regimen.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8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Xenograft study arms and corresponding animal numbers.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chematic of treatment regimen and sample collection.</a:t>
            </a:r>
            <a:r>
              <a:rPr lang="en-US" sz="18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)</a:t>
            </a:r>
            <a:r>
              <a:rPr lang="en-US" sz="1800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Xenografts grouped by treatment and ordered by size. </a:t>
            </a:r>
            <a:endParaRPr lang="en-US" sz="1800" i="1" dirty="0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2795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58</TotalTime>
  <Words>262</Words>
  <Application>Microsoft Office PowerPoint</Application>
  <PresentationFormat>Widescreen</PresentationFormat>
  <Paragraphs>7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Legen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holas Wallace</dc:creator>
  <cp:lastModifiedBy>Nicholas Wallace</cp:lastModifiedBy>
  <cp:revision>12</cp:revision>
  <dcterms:created xsi:type="dcterms:W3CDTF">2026-03-31T21:32:41Z</dcterms:created>
  <dcterms:modified xsi:type="dcterms:W3CDTF">2026-04-03T15:41:40Z</dcterms:modified>
</cp:coreProperties>
</file>